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5/08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5/08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825529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eutsch et al (2022) Diabetologia DOI 10.1007/s00125-022-05769-4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Diabetes subtypes</a:t>
            </a:r>
            <a:endParaRPr lang="en-GB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7653193-CD5E-48DB-F088-196FDB1999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033" y="642055"/>
            <a:ext cx="7578375" cy="50170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1520" y="272842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trategies for identifying diabetes subtype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43DF2B41-5445-A2A3-4C86-B2F99AE17B1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3558" y="698564"/>
            <a:ext cx="7380312" cy="5214712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FFCA87FB-85DC-D629-D1FA-954992C45604}"/>
              </a:ext>
            </a:extLst>
          </p:cNvPr>
          <p:cNvSpPr txBox="1"/>
          <p:nvPr/>
        </p:nvSpPr>
        <p:spPr>
          <a:xfrm>
            <a:off x="278149" y="5996554"/>
            <a:ext cx="799288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eutsch et al (2022) Diabetologia DOI 10.1007/s00125-022-05769-4 </a:t>
            </a:r>
          </a:p>
          <a:p>
            <a:r>
              <a:rPr lang="en-GB" sz="1200" dirty="0"/>
              <a:t>©The Authors 2022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8</Words>
  <Application>Microsoft Office PowerPoint</Application>
  <PresentationFormat>On-screen Show (4:3)</PresentationFormat>
  <Paragraphs>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39</cp:revision>
  <dcterms:created xsi:type="dcterms:W3CDTF">2016-06-15T12:53:43Z</dcterms:created>
  <dcterms:modified xsi:type="dcterms:W3CDTF">2022-08-05T12:00:25Z</dcterms:modified>
</cp:coreProperties>
</file>